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4" r:id="rId3"/>
    <p:sldId id="262" r:id="rId4"/>
    <p:sldId id="265" r:id="rId5"/>
    <p:sldId id="269" r:id="rId6"/>
    <p:sldId id="270" r:id="rId7"/>
    <p:sldId id="272" r:id="rId8"/>
    <p:sldId id="273" r:id="rId9"/>
    <p:sldId id="275" r:id="rId10"/>
    <p:sldId id="277" r:id="rId11"/>
    <p:sldId id="271" r:id="rId12"/>
    <p:sldId id="280" r:id="rId13"/>
    <p:sldId id="282" r:id="rId14"/>
    <p:sldId id="284" r:id="rId15"/>
    <p:sldId id="286" r:id="rId16"/>
    <p:sldId id="281" r:id="rId17"/>
    <p:sldId id="291" r:id="rId18"/>
    <p:sldId id="292" r:id="rId19"/>
    <p:sldId id="293" r:id="rId20"/>
    <p:sldId id="295" r:id="rId21"/>
    <p:sldId id="290" r:id="rId22"/>
    <p:sldId id="298" r:id="rId23"/>
    <p:sldId id="300" r:id="rId24"/>
    <p:sldId id="307" r:id="rId25"/>
    <p:sldId id="308" r:id="rId26"/>
    <p:sldId id="301" r:id="rId27"/>
    <p:sldId id="303" r:id="rId28"/>
    <p:sldId id="304" r:id="rId29"/>
    <p:sldId id="305" r:id="rId30"/>
    <p:sldId id="299" r:id="rId31"/>
    <p:sldId id="310" r:id="rId32"/>
    <p:sldId id="311" r:id="rId33"/>
    <p:sldId id="312" r:id="rId34"/>
    <p:sldId id="313" r:id="rId35"/>
    <p:sldId id="315" r:id="rId36"/>
    <p:sldId id="314" r:id="rId37"/>
    <p:sldId id="316" r:id="rId38"/>
    <p:sldId id="317" r:id="rId39"/>
    <p:sldId id="309" r:id="rId40"/>
    <p:sldId id="326" r:id="rId41"/>
    <p:sldId id="318" r:id="rId42"/>
    <p:sldId id="321" r:id="rId43"/>
    <p:sldId id="323" r:id="rId44"/>
    <p:sldId id="319" r:id="rId45"/>
    <p:sldId id="327" r:id="rId46"/>
    <p:sldId id="329" r:id="rId47"/>
    <p:sldId id="331" r:id="rId48"/>
    <p:sldId id="333" r:id="rId49"/>
    <p:sldId id="328" r:id="rId50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F8214282-853E-44F0-AD69-641DF3D31837}">
          <p14:sldIdLst>
            <p14:sldId id="257"/>
          </p14:sldIdLst>
        </p14:section>
        <p14:section name="-/-/-" id="{22D3B74B-B559-4A3A-AA14-FCA5081B32AF}">
          <p14:sldIdLst>
            <p14:sldId id="264"/>
            <p14:sldId id="262"/>
            <p14:sldId id="265"/>
            <p14:sldId id="269"/>
            <p14:sldId id="270"/>
            <p14:sldId id="272"/>
            <p14:sldId id="273"/>
            <p14:sldId id="275"/>
            <p14:sldId id="277"/>
            <p14:sldId id="271"/>
          </p14:sldIdLst>
        </p14:section>
        <p14:section name="+/+/+" id="{4B6741D6-B34A-48AE-82E0-AC4D5C6BB881}">
          <p14:sldIdLst>
            <p14:sldId id="280"/>
            <p14:sldId id="282"/>
            <p14:sldId id="284"/>
            <p14:sldId id="286"/>
            <p14:sldId id="281"/>
            <p14:sldId id="291"/>
            <p14:sldId id="292"/>
            <p14:sldId id="293"/>
            <p14:sldId id="295"/>
            <p14:sldId id="290"/>
            <p14:sldId id="298"/>
            <p14:sldId id="300"/>
            <p14:sldId id="307"/>
            <p14:sldId id="308"/>
            <p14:sldId id="301"/>
            <p14:sldId id="303"/>
            <p14:sldId id="304"/>
            <p14:sldId id="305"/>
            <p14:sldId id="299"/>
            <p14:sldId id="310"/>
            <p14:sldId id="311"/>
            <p14:sldId id="312"/>
            <p14:sldId id="313"/>
            <p14:sldId id="315"/>
            <p14:sldId id="314"/>
            <p14:sldId id="316"/>
            <p14:sldId id="317"/>
            <p14:sldId id="309"/>
          </p14:sldIdLst>
        </p14:section>
        <p14:section name="-/+/+" id="{3BA8936C-1E0D-4434-8F2B-A1A722D28F61}">
          <p14:sldIdLst>
            <p14:sldId id="326"/>
            <p14:sldId id="318"/>
            <p14:sldId id="321"/>
            <p14:sldId id="323"/>
            <p14:sldId id="319"/>
            <p14:sldId id="327"/>
            <p14:sldId id="329"/>
            <p14:sldId id="331"/>
            <p14:sldId id="333"/>
            <p14:sldId id="32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73" autoAdjust="0"/>
    <p:restoredTop sz="94660"/>
  </p:normalViewPr>
  <p:slideViewPr>
    <p:cSldViewPr snapToGrid="0">
      <p:cViewPr>
        <p:scale>
          <a:sx n="100" d="100"/>
          <a:sy n="100" d="100"/>
        </p:scale>
        <p:origin x="1152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8" Type="http://schemas.openxmlformats.org/officeDocument/2006/relationships/slide" Target="slides/slide7.xml"/><Relationship Id="rId51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4306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2581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7578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8312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1231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787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7533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8132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8026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614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6511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E1029-EA77-46A9-B16B-AE3D824D55DE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602A6-C169-4F92-936B-8683674073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91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26" Type="http://schemas.openxmlformats.org/officeDocument/2006/relationships/image" Target="../media/image22.png"/><Relationship Id="rId3" Type="http://schemas.microsoft.com/office/2007/relationships/hdphoto" Target="../media/hdphoto1.wdp"/><Relationship Id="rId21" Type="http://schemas.openxmlformats.org/officeDocument/2006/relationships/image" Target="../media/image17.pn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24" Type="http://schemas.openxmlformats.org/officeDocument/2006/relationships/image" Target="../media/image20.png"/><Relationship Id="rId5" Type="http://schemas.openxmlformats.org/officeDocument/2006/relationships/image" Target="../media/image3.png"/><Relationship Id="rId15" Type="http://schemas.openxmlformats.org/officeDocument/2006/relationships/image" Target="../media/image11.png"/><Relationship Id="rId23" Type="http://schemas.openxmlformats.org/officeDocument/2006/relationships/image" Target="../media/image19.png"/><Relationship Id="rId28" Type="http://schemas.openxmlformats.org/officeDocument/2006/relationships/image" Target="../media/image24.png"/><Relationship Id="rId10" Type="http://schemas.microsoft.com/office/2007/relationships/hdphoto" Target="../media/hdphoto3.wdp"/><Relationship Id="rId19" Type="http://schemas.openxmlformats.org/officeDocument/2006/relationships/image" Target="../media/image15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0.png"/><Relationship Id="rId22" Type="http://schemas.openxmlformats.org/officeDocument/2006/relationships/image" Target="../media/image18.png"/><Relationship Id="rId27" Type="http://schemas.openxmlformats.org/officeDocument/2006/relationships/image" Target="../media/image2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image" Target="../media/image15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png"/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png"/><Relationship Id="rId9" Type="http://schemas.openxmlformats.org/officeDocument/2006/relationships/image" Target="../media/image7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8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21922" y="95338"/>
            <a:ext cx="2209800" cy="2219325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1922" y="2468063"/>
            <a:ext cx="2209800" cy="22193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51033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i="1" dirty="0">
                <a:latin typeface="Arial" panose="020B0604020202020204" pitchFamily="34" charset="0"/>
                <a:cs typeface="Arial" panose="020B0604020202020204" pitchFamily="34" charset="0"/>
              </a:rPr>
              <a:t>Aldh1l1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321922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419857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2790747" y="-863834"/>
            <a:ext cx="932306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 (Control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-2790747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419257" y="95338"/>
            <a:ext cx="2209800" cy="2219325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51633" y="95338"/>
            <a:ext cx="2209800" cy="2219325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2790147" y="95337"/>
            <a:ext cx="2209800" cy="2219325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803678" y="95337"/>
            <a:ext cx="2211601" cy="2219325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434591" y="95337"/>
            <a:ext cx="2209800" cy="2219325"/>
          </a:xfrm>
          <a:prstGeom prst="rect">
            <a:avLst/>
          </a:prstGeom>
        </p:spPr>
      </p:pic>
      <p:pic>
        <p:nvPicPr>
          <p:cNvPr id="23" name="그림 2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062499" y="95337"/>
            <a:ext cx="2211002" cy="2219325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692211" y="95337"/>
            <a:ext cx="2209800" cy="2219325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1433991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i="1" dirty="0">
                <a:latin typeface="Arial" panose="020B0604020202020204" pitchFamily="34" charset="0"/>
                <a:cs typeface="Arial" panose="020B0604020202020204" pitchFamily="34" charset="0"/>
              </a:rPr>
              <a:t>Aldh1l1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3804880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063101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692211" y="-863834"/>
            <a:ext cx="932306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-2A-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692211" y="-402436"/>
            <a:ext cx="22104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이등변 삼각형 1"/>
          <p:cNvSpPr/>
          <p:nvPr/>
        </p:nvSpPr>
        <p:spPr>
          <a:xfrm rot="7942281">
            <a:off x="14364155" y="196269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이등변 삼각형 30"/>
          <p:cNvSpPr/>
          <p:nvPr/>
        </p:nvSpPr>
        <p:spPr>
          <a:xfrm rot="9579792">
            <a:off x="15340469" y="1539293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이등변 삼각형 31"/>
          <p:cNvSpPr/>
          <p:nvPr/>
        </p:nvSpPr>
        <p:spPr>
          <a:xfrm rot="16200000">
            <a:off x="15106438" y="610984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/>
          <p:cNvSpPr txBox="1"/>
          <p:nvPr/>
        </p:nvSpPr>
        <p:spPr>
          <a:xfrm>
            <a:off x="-3704968" y="-863834"/>
            <a:ext cx="753731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</a:p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MP4</a:t>
            </a:r>
          </a:p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LIF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-3487763" y="658557"/>
            <a:ext cx="3193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-3477029" y="3006322"/>
            <a:ext cx="26161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그림 4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-419857" y="2468063"/>
            <a:ext cx="2209800" cy="2219325"/>
          </a:xfrm>
          <a:prstGeom prst="rect">
            <a:avLst/>
          </a:prstGeom>
        </p:spPr>
      </p:pic>
      <p:pic>
        <p:nvPicPr>
          <p:cNvPr id="43" name="그림 4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51633" y="2468063"/>
            <a:ext cx="2209800" cy="2219325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-2790447" y="2468063"/>
            <a:ext cx="2209800" cy="2219325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063100" y="2473610"/>
            <a:ext cx="2209800" cy="2219325"/>
          </a:xfrm>
          <a:prstGeom prst="rect">
            <a:avLst/>
          </a:prstGeom>
        </p:spPr>
      </p:pic>
      <p:pic>
        <p:nvPicPr>
          <p:cNvPr id="46" name="그림 45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3802102" y="2468062"/>
            <a:ext cx="2209800" cy="2219325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1434591" y="2468062"/>
            <a:ext cx="2209800" cy="2219325"/>
          </a:xfrm>
          <a:prstGeom prst="rect">
            <a:avLst/>
          </a:prstGeom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692211" y="2468063"/>
            <a:ext cx="2209800" cy="2219325"/>
          </a:xfrm>
          <a:prstGeom prst="rect">
            <a:avLst/>
          </a:prstGeom>
        </p:spPr>
      </p:pic>
      <p:sp>
        <p:nvSpPr>
          <p:cNvPr id="49" name="이등변 삼각형 48"/>
          <p:cNvSpPr/>
          <p:nvPr/>
        </p:nvSpPr>
        <p:spPr>
          <a:xfrm rot="1165194">
            <a:off x="14436335" y="3507982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이등변 삼각형 49"/>
          <p:cNvSpPr/>
          <p:nvPr/>
        </p:nvSpPr>
        <p:spPr>
          <a:xfrm rot="12500485">
            <a:off x="15387598" y="3647105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2" name="그림 5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3800143" y="4837798"/>
            <a:ext cx="2210400" cy="2218438"/>
          </a:xfrm>
          <a:prstGeom prst="rect">
            <a:avLst/>
          </a:prstGeom>
        </p:spPr>
      </p:pic>
      <p:pic>
        <p:nvPicPr>
          <p:cNvPr id="53" name="그림 5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062499" y="4851883"/>
            <a:ext cx="2210400" cy="2218438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1433387" y="4851883"/>
            <a:ext cx="2210400" cy="2218438"/>
          </a:xfrm>
          <a:prstGeom prst="rect">
            <a:avLst/>
          </a:prstGeom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691611" y="4840789"/>
            <a:ext cx="2210400" cy="2218438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-2803933" y="4815829"/>
            <a:ext cx="2213004" cy="2221200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-418931" y="4837798"/>
            <a:ext cx="2213004" cy="2221200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950429" y="4837798"/>
            <a:ext cx="2213004" cy="2221200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318119" y="4837798"/>
            <a:ext cx="2213004" cy="2221200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-3519369" y="5352351"/>
            <a:ext cx="3193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이등변 삼각형 62"/>
          <p:cNvSpPr/>
          <p:nvPr/>
        </p:nvSpPr>
        <p:spPr>
          <a:xfrm rot="13148133">
            <a:off x="14829143" y="5426160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이등변 삼각형 63"/>
          <p:cNvSpPr/>
          <p:nvPr/>
        </p:nvSpPr>
        <p:spPr>
          <a:xfrm rot="7198131">
            <a:off x="14506738" y="4900273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이등변 삼각형 64"/>
          <p:cNvSpPr/>
          <p:nvPr/>
        </p:nvSpPr>
        <p:spPr>
          <a:xfrm rot="2465892">
            <a:off x="15543518" y="5696741"/>
            <a:ext cx="152400" cy="241300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10" name="직선 연결선 109"/>
          <p:cNvCxnSpPr/>
          <p:nvPr/>
        </p:nvCxnSpPr>
        <p:spPr>
          <a:xfrm>
            <a:off x="-1567925" y="2137960"/>
            <a:ext cx="7632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08950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7405" y="1548687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317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/-/-_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4419" y="1442257"/>
            <a:ext cx="2209800" cy="221932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81777" y="1442256"/>
            <a:ext cx="2209800" cy="2219325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8098" y="1436906"/>
            <a:ext cx="2209800" cy="2219325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0739" y="1436906"/>
            <a:ext cx="2209800" cy="2219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9049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1952" y="1213368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197570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1952" y="1213368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38895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1952" y="1213368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84254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4334" y="1455186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038523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2554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/+/+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481777" y="1436905"/>
            <a:ext cx="2209800" cy="22193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4419" y="1436905"/>
            <a:ext cx="2209800" cy="2219325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48097" y="1436905"/>
            <a:ext cx="2209800" cy="2219325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80739" y="1436904"/>
            <a:ext cx="2209800" cy="2219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41153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02346">
            <a:off x="3143250" y="681524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3056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02346">
            <a:off x="2891323" y="597549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981269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02346">
            <a:off x="2891323" y="597549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5934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2988" y="1874588"/>
            <a:ext cx="3952875" cy="39528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12384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02346">
            <a:off x="3655850" y="1831365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704864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242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/+/+_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456160" y="1436903"/>
            <a:ext cx="2209800" cy="2219325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8099" y="1436903"/>
            <a:ext cx="2209800" cy="2219325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14419" y="1436903"/>
            <a:ext cx="2209800" cy="2219325"/>
          </a:xfrm>
          <a:prstGeom prst="rect">
            <a:avLst/>
          </a:prstGeom>
        </p:spPr>
      </p:pic>
      <p:pic>
        <p:nvPicPr>
          <p:cNvPr id="23" name="그림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80739" y="1436902"/>
            <a:ext cx="2209800" cy="2219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722502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3222655" y="709903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500151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3229635" y="709903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941442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592497">
            <a:off x="3779267" y="1624303"/>
            <a:ext cx="4619625" cy="40767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54755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3226145" y="709903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551977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594238">
            <a:off x="3621238" y="1356340"/>
            <a:ext cx="5133975" cy="515302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573291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4087468" y="1661045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923341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4090958" y="1661045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93574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09765">
            <a:off x="4083978" y="1661045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07395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5527" y="1856232"/>
            <a:ext cx="3952875" cy="39528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879267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/-/-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154506" y="6096286"/>
            <a:ext cx="813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6160" y="1436901"/>
            <a:ext cx="2209800" cy="22193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56160" y="3766593"/>
            <a:ext cx="2209800" cy="221932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0739" y="1436901"/>
            <a:ext cx="2209800" cy="2219325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0734" y="3766592"/>
            <a:ext cx="2209800" cy="2219325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4419" y="1436901"/>
            <a:ext cx="2209800" cy="2219325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01606" y="3758558"/>
            <a:ext cx="2209800" cy="2219325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35289" y="1436900"/>
            <a:ext cx="2209800" cy="2219325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48097" y="3758556"/>
            <a:ext cx="2209800" cy="2219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500343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988" y="667079"/>
            <a:ext cx="5886450" cy="58864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569243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988" y="667079"/>
            <a:ext cx="5886450" cy="58864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275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988" y="667079"/>
            <a:ext cx="5886450" cy="58864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035790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988" y="667079"/>
            <a:ext cx="5886450" cy="58864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87254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4988" y="667079"/>
            <a:ext cx="5886450" cy="58864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636231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1873" y="1719397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06368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1873" y="1719397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248464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1873" y="1719397"/>
            <a:ext cx="4133850" cy="413385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142608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+/-/-_p18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154506" y="6096286"/>
            <a:ext cx="813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9063" y="3756681"/>
            <a:ext cx="2213152" cy="22212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56159" y="1435025"/>
            <a:ext cx="2211458" cy="2221200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8402" y="1435025"/>
            <a:ext cx="2213004" cy="2221200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8402" y="3756681"/>
            <a:ext cx="2213004" cy="2221200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27280" y="1435025"/>
            <a:ext cx="2213004" cy="2221200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36969" y="3766593"/>
            <a:ext cx="2213004" cy="2221200"/>
          </a:xfrm>
          <a:prstGeom prst="rect">
            <a:avLst/>
          </a:prstGeom>
        </p:spPr>
      </p:pic>
      <p:pic>
        <p:nvPicPr>
          <p:cNvPr id="23" name="그림 2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69523" y="1435025"/>
            <a:ext cx="2213004" cy="2221200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454558" y="3774630"/>
            <a:ext cx="2213004" cy="222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77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2037" y="1856539"/>
            <a:ext cx="3952875" cy="39528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085496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4660" y="708660"/>
            <a:ext cx="5867400" cy="58674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311204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2205" y="1785821"/>
            <a:ext cx="3952875" cy="39528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52811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4660" y="708660"/>
            <a:ext cx="5867400" cy="58674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6412104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4660" y="708660"/>
            <a:ext cx="5867400" cy="58674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3026939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/+/+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6007" y="1435025"/>
            <a:ext cx="2213004" cy="2221200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5648" y="1435025"/>
            <a:ext cx="2213004" cy="2221200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5289" y="1435025"/>
            <a:ext cx="2213004" cy="2221200"/>
          </a:xfrm>
          <a:prstGeom prst="rect">
            <a:avLst/>
          </a:prstGeom>
        </p:spPr>
      </p:pic>
      <p:pic>
        <p:nvPicPr>
          <p:cNvPr id="23" name="그림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54558" y="1435025"/>
            <a:ext cx="2213004" cy="222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512907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9383" y="683760"/>
            <a:ext cx="5838825" cy="583882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299047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9381" y="683756"/>
            <a:ext cx="5838825" cy="583882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0429561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9382" y="683756"/>
            <a:ext cx="5838825" cy="583882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2824289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9127" y="1910299"/>
            <a:ext cx="4029075" cy="40290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7822128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/+/+_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연결선 16"/>
          <p:cNvCxnSpPr/>
          <p:nvPr/>
        </p:nvCxnSpPr>
        <p:spPr>
          <a:xfrm>
            <a:off x="1822439" y="1595040"/>
            <a:ext cx="15264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1400" y="1436406"/>
            <a:ext cx="2210400" cy="221843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8252" y="1435025"/>
            <a:ext cx="2210400" cy="2218438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4826" y="1435025"/>
            <a:ext cx="2210400" cy="2218438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01678" y="1435025"/>
            <a:ext cx="2210400" cy="2218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2889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2802" y="2349465"/>
            <a:ext cx="2924175" cy="29241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1937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0740" y="1442257"/>
            <a:ext cx="2209800" cy="2219325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81777" y="1442258"/>
            <a:ext cx="2209800" cy="22193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14419" y="1442258"/>
            <a:ext cx="2209800" cy="22193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/-/-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7150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KO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154506" y="96523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6476" y="96523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48098" y="1442258"/>
            <a:ext cx="2209800" cy="221932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217590" y="96523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7579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968" y="662862"/>
            <a:ext cx="5905500" cy="590550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5968" y="662862"/>
            <a:ext cx="5905500" cy="59055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65968" y="662862"/>
            <a:ext cx="5905500" cy="5905500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65968" y="662862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54157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7971" y="1975853"/>
            <a:ext cx="4114800" cy="3876675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85011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5968" y="662862"/>
            <a:ext cx="5905500" cy="590550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668796" y="2702064"/>
            <a:ext cx="2154804" cy="216851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3077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</TotalTime>
  <Words>79</Words>
  <Application>Microsoft Office PowerPoint</Application>
  <PresentationFormat>와이드스크린</PresentationFormat>
  <Paragraphs>64</Paragraphs>
  <Slides>4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9</vt:i4>
      </vt:variant>
    </vt:vector>
  </HeadingPairs>
  <TitlesOfParts>
    <vt:vector size="52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이 원영</cp:lastModifiedBy>
  <cp:revision>46</cp:revision>
  <cp:lastPrinted>2019-02-22T09:49:54Z</cp:lastPrinted>
  <dcterms:created xsi:type="dcterms:W3CDTF">2019-01-29T07:27:09Z</dcterms:created>
  <dcterms:modified xsi:type="dcterms:W3CDTF">2024-09-27T02:50:48Z</dcterms:modified>
</cp:coreProperties>
</file>